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3" r:id="rId2"/>
    <p:sldId id="322" r:id="rId3"/>
    <p:sldId id="321" r:id="rId4"/>
    <p:sldId id="324" r:id="rId5"/>
    <p:sldId id="326" r:id="rId6"/>
    <p:sldId id="325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5" d="100"/>
          <a:sy n="85" d="100"/>
        </p:scale>
        <p:origin x="535" y="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E68934-A06B-4E73-98FD-6533D00FB4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370DD22-D180-4DB5-B613-B544EAE7A0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CFBD1F-20BB-4477-B340-7D93304312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91F61A-06A6-41EF-8297-46C561FAF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442746-F744-43A0-94F1-E723955FA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5654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A56B7C-C19F-4543-9046-EA688E9EEF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8A46BCB-9811-464D-9408-DDB05C37CA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5431AB-A7E7-43EA-9AD5-08EA968C2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2AC4D7-6F8E-4C8D-8ADC-BD4F4A107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47623D4-2F50-47EB-9FE3-382FD9D75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9746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561AB46-78CD-4FBC-B474-4CBB16E60B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AA00170-383B-44A0-93AF-FC25A6969B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3A1D84-EB7F-4078-B797-CFB85B806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6F1FDA-1D76-4068-A268-6C597413F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394A87-3BB7-4F55-A5A8-550DE2E17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0747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860C3B-2D40-4665-BEF0-0F13062C81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4E2BFAC-573E-4221-B3A0-404882B334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30DAE2-37C1-4514-88C5-504AB7E12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3767A4-4DF3-4F67-BEF2-131F63EDB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3381AB-DEAF-49F5-908F-CCAFE9968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0417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50D7C8-F63B-44F0-A2BF-D631AB60EF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C1B9EF-4290-46F8-AFC0-07C20C1AF9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DE079E-35B6-46CF-A90F-D616288D2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F168ED-83B9-4912-A5F2-AAA4CA8EE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B79368-676F-4B6B-96D2-9959AAADB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8460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CFECF0-2987-4E25-AE02-F235C7ADAE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374EEF3-50C9-4A41-90D3-8EAFF5B57D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4E8A955-0577-42B6-BC74-D69FA7B9B0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C7253CA-8020-4160-A126-075467C85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A8C4929-7192-420B-B479-7FA0FCF92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2579FBB-6C6A-4FEF-9C12-BCAD250F4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5668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AC4290-0149-438B-BA03-78FB5FB566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1FEE8C5-FD88-49E7-A96A-95631C3B0F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A19FAE9-81A7-4930-B790-ED6D211AF2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167954D-6851-4A21-A34A-3B12F15F51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708DA93-A610-4990-A401-C457818174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5E7AF61-CD10-4D65-9766-4673838B0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0823B95-9ABE-4B80-BD25-74038B7F8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FCA78B0-1764-4954-8188-D86BE226B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5936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B30FA3-AE8F-443F-81E2-A64D07035E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EABC91A-522E-4BA2-A00B-EBC7006BF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F312D57-FEE9-4789-91AF-AA3F56BF1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B065632-CB06-475A-B1E7-97C3A52C8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6227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89E1CCB-9B1C-4B79-9B55-63E35CCB5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B035E48-0DDD-47CD-BB25-CA839F433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48FFF6D-38D2-4598-8558-6397681BD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7705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095676-5479-4966-A1FF-A4D7D614F6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B97A65-C05D-4B88-AC1A-FCCE0C67DA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F8EDF63-104A-4BA3-809E-4117847C96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4A11035-F98B-4537-B53D-732632AFD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F574CCD-ABD7-40BF-9846-3EF16BE94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2315551-8E4F-47EA-ABD4-6FB6E9FDD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5580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053C30-5818-4A04-94F0-25DA4CDF6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6A8633C-D22E-483B-B8C2-AC82427F96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077A13B-62BE-4E86-9137-C19690AB84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C3B6DBE-E192-471B-AD66-BE2780BC0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C4594C-AFD0-4BA3-8A58-8C42D390D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376C15-E198-4C48-BBB3-2642F4A1E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6255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6418289-53A5-4A07-BE37-779A8E403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B6EBB89-006D-4290-809E-47B5FB788E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852B9E-23EA-4EB1-8E64-70419DF35B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3C15A6-3711-474A-98B0-2551FD909CFB}" type="datetimeFigureOut">
              <a:rPr lang="zh-CN" altLang="en-US" smtClean="0"/>
              <a:t>2013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914775-06C0-42C7-845F-D721F8AC44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DBDAA1-DF9B-4FB0-9ED1-ADA247FCC7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5105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5316102E-7D08-4C66-873A-538EF550990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72" b="52647"/>
          <a:stretch/>
        </p:blipFill>
        <p:spPr>
          <a:xfrm>
            <a:off x="8691563" y="2145791"/>
            <a:ext cx="3500437" cy="4666671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7009046F-583F-4713-A01A-C39F4FBE3448}"/>
              </a:ext>
            </a:extLst>
          </p:cNvPr>
          <p:cNvSpPr txBox="1"/>
          <p:nvPr/>
        </p:nvSpPr>
        <p:spPr>
          <a:xfrm>
            <a:off x="219033" y="167176"/>
            <a:ext cx="2868093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6A-RhoA-panel 1#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29F4B30-0742-4A7E-AC96-E1B7F096F7F4}"/>
              </a:ext>
            </a:extLst>
          </p:cNvPr>
          <p:cNvSpPr txBox="1"/>
          <p:nvPr/>
        </p:nvSpPr>
        <p:spPr>
          <a:xfrm rot="18046475">
            <a:off x="9837534" y="758920"/>
            <a:ext cx="106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0 min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69DB464-C6BE-4A24-BA9B-5945107D5C3B}"/>
              </a:ext>
            </a:extLst>
          </p:cNvPr>
          <p:cNvSpPr txBox="1"/>
          <p:nvPr/>
        </p:nvSpPr>
        <p:spPr>
          <a:xfrm rot="18046475">
            <a:off x="9575172" y="764396"/>
            <a:ext cx="106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 min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D7EE999-4A86-4266-98FE-5597D2F529FB}"/>
              </a:ext>
            </a:extLst>
          </p:cNvPr>
          <p:cNvSpPr txBox="1"/>
          <p:nvPr/>
        </p:nvSpPr>
        <p:spPr>
          <a:xfrm rot="18046475">
            <a:off x="9291722" y="730473"/>
            <a:ext cx="106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 min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8167B26B-4D7C-491B-84F5-A92BB29AB99B}"/>
              </a:ext>
            </a:extLst>
          </p:cNvPr>
          <p:cNvSpPr txBox="1"/>
          <p:nvPr/>
        </p:nvSpPr>
        <p:spPr>
          <a:xfrm rot="18046475">
            <a:off x="8996285" y="744697"/>
            <a:ext cx="106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 min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5D1851C-EDE4-4968-8361-D33FDDB297FE}"/>
              </a:ext>
            </a:extLst>
          </p:cNvPr>
          <p:cNvSpPr txBox="1"/>
          <p:nvPr/>
        </p:nvSpPr>
        <p:spPr>
          <a:xfrm rot="17916322">
            <a:off x="8685799" y="748612"/>
            <a:ext cx="106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0 min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87254225-16B6-40D9-A39F-D4C6EAE1C09F}"/>
              </a:ext>
            </a:extLst>
          </p:cNvPr>
          <p:cNvSpPr txBox="1"/>
          <p:nvPr/>
        </p:nvSpPr>
        <p:spPr>
          <a:xfrm>
            <a:off x="10654633" y="1415638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RhoA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7B1A4DFB-E638-497F-9C94-B6058621D6F4}"/>
              </a:ext>
            </a:extLst>
          </p:cNvPr>
          <p:cNvCxnSpPr>
            <a:cxnSpLocks/>
          </p:cNvCxnSpPr>
          <p:nvPr/>
        </p:nvCxnSpPr>
        <p:spPr>
          <a:xfrm>
            <a:off x="9064546" y="1906610"/>
            <a:ext cx="1590087" cy="750865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45" name="Picture 1">
            <a:extLst>
              <a:ext uri="{FF2B5EF4-FFF2-40B4-BE49-F238E27FC236}">
                <a16:creationId xmlns:a16="http://schemas.microsoft.com/office/drawing/2014/main" id="{C986791F-3A7B-454D-8CBD-139A0574F84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126" y="885825"/>
            <a:ext cx="3876746" cy="2924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2">
            <a:extLst>
              <a:ext uri="{FF2B5EF4-FFF2-40B4-BE49-F238E27FC236}">
                <a16:creationId xmlns:a16="http://schemas.microsoft.com/office/drawing/2014/main" id="{CE81DA8D-5415-4FEE-A175-25E40627BA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0125" y="3626087"/>
            <a:ext cx="116205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33156" tIns="26979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1dsfh.tif</a:t>
            </a:r>
            <a:endParaRPr kumimoji="0" lang="zh-CN" altLang="zh-CN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6" name="Picture 1">
            <a:extLst>
              <a:ext uri="{FF2B5EF4-FFF2-40B4-BE49-F238E27FC236}">
                <a16:creationId xmlns:a16="http://schemas.microsoft.com/office/drawing/2014/main" id="{67693502-319F-4B33-8DDD-C3FA418AE2D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819"/>
          <a:stretch/>
        </p:blipFill>
        <p:spPr bwMode="auto">
          <a:xfrm>
            <a:off x="6472833" y="1383868"/>
            <a:ext cx="3876746" cy="5608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A512A56F-4BAB-4372-A8C6-B5468B7EEB0D}"/>
              </a:ext>
            </a:extLst>
          </p:cNvPr>
          <p:cNvCxnSpPr>
            <a:cxnSpLocks/>
          </p:cNvCxnSpPr>
          <p:nvPr/>
        </p:nvCxnSpPr>
        <p:spPr>
          <a:xfrm flipV="1">
            <a:off x="4000161" y="1714500"/>
            <a:ext cx="2362539" cy="170610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4F78F3DC-401F-465F-95D1-F29773F085B3}"/>
              </a:ext>
            </a:extLst>
          </p:cNvPr>
          <p:cNvSpPr txBox="1"/>
          <p:nvPr/>
        </p:nvSpPr>
        <p:spPr>
          <a:xfrm rot="12005199">
            <a:off x="6859322" y="254652"/>
            <a:ext cx="400110" cy="112628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/>
              <a:t>RhoA-G14V</a:t>
            </a:r>
            <a:endParaRPr lang="zh-CN" altLang="en-US" sz="12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AD8B9C4-E08B-4304-969B-56564F916949}"/>
              </a:ext>
            </a:extLst>
          </p:cNvPr>
          <p:cNvSpPr txBox="1"/>
          <p:nvPr/>
        </p:nvSpPr>
        <p:spPr>
          <a:xfrm rot="12005199">
            <a:off x="7180235" y="293127"/>
            <a:ext cx="400110" cy="108660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/>
              <a:t>RhoA-WT</a:t>
            </a:r>
            <a:endParaRPr lang="zh-CN" altLang="en-US" sz="14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2C34684-20E6-4926-9E97-EEDFB2618B0E}"/>
              </a:ext>
            </a:extLst>
          </p:cNvPr>
          <p:cNvSpPr txBox="1"/>
          <p:nvPr/>
        </p:nvSpPr>
        <p:spPr>
          <a:xfrm rot="12005199">
            <a:off x="7507505" y="217673"/>
            <a:ext cx="400110" cy="117951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/>
              <a:t>RhoA-F39A</a:t>
            </a:r>
            <a:endParaRPr lang="zh-CN" altLang="en-US" sz="12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5C24474-5ACA-49FB-80FD-C8B383D91EE0}"/>
              </a:ext>
            </a:extLst>
          </p:cNvPr>
          <p:cNvSpPr txBox="1"/>
          <p:nvPr/>
        </p:nvSpPr>
        <p:spPr>
          <a:xfrm rot="12005199">
            <a:off x="7751922" y="253013"/>
            <a:ext cx="400110" cy="114643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/>
              <a:t>RhoA-T19N</a:t>
            </a:r>
            <a:endParaRPr lang="zh-CN" altLang="en-US" sz="12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4A56663-2589-4F6C-937E-00D49E292681}"/>
              </a:ext>
            </a:extLst>
          </p:cNvPr>
          <p:cNvSpPr txBox="1"/>
          <p:nvPr/>
        </p:nvSpPr>
        <p:spPr>
          <a:xfrm rot="12005199">
            <a:off x="8262217" y="437752"/>
            <a:ext cx="400110" cy="96112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 err="1"/>
              <a:t>RacI</a:t>
            </a:r>
            <a:r>
              <a:rPr lang="en-US" altLang="zh-CN" sz="1400" dirty="0"/>
              <a:t>-WT</a:t>
            </a:r>
            <a:endParaRPr lang="zh-CN" altLang="en-US" sz="14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3D1F4CE-DFF3-427C-9B33-C9A8C8211E17}"/>
              </a:ext>
            </a:extLst>
          </p:cNvPr>
          <p:cNvSpPr txBox="1"/>
          <p:nvPr/>
        </p:nvSpPr>
        <p:spPr>
          <a:xfrm rot="12005199">
            <a:off x="8571662" y="268720"/>
            <a:ext cx="400110" cy="1156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/>
              <a:t>RacI-T17N</a:t>
            </a:r>
            <a:endParaRPr lang="zh-CN" altLang="en-US" sz="1400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4B36715C-0DD4-4065-8762-0540040BB423}"/>
              </a:ext>
            </a:extLst>
          </p:cNvPr>
          <p:cNvSpPr txBox="1"/>
          <p:nvPr/>
        </p:nvSpPr>
        <p:spPr>
          <a:xfrm rot="12005199">
            <a:off x="8034843" y="348598"/>
            <a:ext cx="400110" cy="105828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/>
              <a:t>CDC42-WT</a:t>
            </a:r>
            <a:endParaRPr lang="zh-CN" altLang="en-US" sz="1200" dirty="0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9D2385DD-E699-4272-881D-44AFD59E4807}"/>
              </a:ext>
            </a:extLst>
          </p:cNvPr>
          <p:cNvSpPr/>
          <p:nvPr/>
        </p:nvSpPr>
        <p:spPr>
          <a:xfrm>
            <a:off x="8862141" y="1382329"/>
            <a:ext cx="1441231" cy="5608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19741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12825382-DCC4-49D4-B24F-7AF84DED5D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163" y="1549888"/>
            <a:ext cx="4370845" cy="138049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316102E-7D08-4C66-873A-538EF550990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72" b="52647"/>
          <a:stretch/>
        </p:blipFill>
        <p:spPr>
          <a:xfrm>
            <a:off x="7566492" y="1979944"/>
            <a:ext cx="3500437" cy="4666671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7009046F-583F-4713-A01A-C39F4FBE3448}"/>
              </a:ext>
            </a:extLst>
          </p:cNvPr>
          <p:cNvSpPr txBox="1"/>
          <p:nvPr/>
        </p:nvSpPr>
        <p:spPr>
          <a:xfrm>
            <a:off x="219033" y="167176"/>
            <a:ext cx="2868093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6A-RhoA-panel 2#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CBE7CC0-2907-4474-AE36-4DD35F87A3EB}"/>
              </a:ext>
            </a:extLst>
          </p:cNvPr>
          <p:cNvSpPr txBox="1"/>
          <p:nvPr/>
        </p:nvSpPr>
        <p:spPr>
          <a:xfrm>
            <a:off x="2419924" y="3061269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sehj.tif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32551F0-4008-4411-8A22-20F493D83BBB}"/>
              </a:ext>
            </a:extLst>
          </p:cNvPr>
          <p:cNvSpPr txBox="1"/>
          <p:nvPr/>
        </p:nvSpPr>
        <p:spPr>
          <a:xfrm>
            <a:off x="5217901" y="2358663"/>
            <a:ext cx="13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ve RhoA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4A538FA-BF3E-47DB-B7CE-0774D476A25D}"/>
              </a:ext>
            </a:extLst>
          </p:cNvPr>
          <p:cNvSpPr txBox="1"/>
          <p:nvPr/>
        </p:nvSpPr>
        <p:spPr>
          <a:xfrm>
            <a:off x="5176391" y="1671041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44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5D1851C-EDE4-4968-8361-D33FDDB297FE}"/>
              </a:ext>
            </a:extLst>
          </p:cNvPr>
          <p:cNvSpPr txBox="1"/>
          <p:nvPr/>
        </p:nvSpPr>
        <p:spPr>
          <a:xfrm rot="18046475">
            <a:off x="3809925" y="947767"/>
            <a:ext cx="101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0 min</a:t>
            </a:r>
            <a:endParaRPr lang="zh-CN" altLang="en-US" dirty="0"/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EA301307-1203-4706-9614-B577F30B4EBE}"/>
              </a:ext>
            </a:extLst>
          </p:cNvPr>
          <p:cNvGrpSpPr/>
          <p:nvPr/>
        </p:nvGrpSpPr>
        <p:grpSpPr>
          <a:xfrm>
            <a:off x="2210944" y="356637"/>
            <a:ext cx="2760564" cy="1281179"/>
            <a:chOff x="7661485" y="7647"/>
            <a:chExt cx="2760564" cy="1281179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4B31D532-5CBE-4858-A605-55FAF6C6BAC7}"/>
                </a:ext>
              </a:extLst>
            </p:cNvPr>
            <p:cNvSpPr txBox="1"/>
            <p:nvPr/>
          </p:nvSpPr>
          <p:spPr>
            <a:xfrm rot="18046475">
              <a:off x="7209199" y="459933"/>
              <a:ext cx="12739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RhoA-WT</a:t>
              </a:r>
              <a:endParaRPr lang="zh-CN" altLang="en-US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929F4B30-0742-4A7E-AC96-E1B7F096F7F4}"/>
                </a:ext>
              </a:extLst>
            </p:cNvPr>
            <p:cNvSpPr txBox="1"/>
            <p:nvPr/>
          </p:nvSpPr>
          <p:spPr>
            <a:xfrm rot="18046475">
              <a:off x="7694360" y="530093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0 min</a:t>
              </a:r>
              <a:endParaRPr lang="zh-CN" altLang="en-US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69DB464-C6BE-4A24-BA9B-5945107D5C3B}"/>
                </a:ext>
              </a:extLst>
            </p:cNvPr>
            <p:cNvSpPr txBox="1"/>
            <p:nvPr/>
          </p:nvSpPr>
          <p:spPr>
            <a:xfrm rot="18046475">
              <a:off x="8123648" y="565811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0 min</a:t>
              </a:r>
              <a:endParaRPr lang="zh-CN" altLang="en-US" dirty="0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7D7EE999-4A86-4266-98FE-5597D2F529FB}"/>
                </a:ext>
              </a:extLst>
            </p:cNvPr>
            <p:cNvSpPr txBox="1"/>
            <p:nvPr/>
          </p:nvSpPr>
          <p:spPr>
            <a:xfrm rot="18046475">
              <a:off x="8518066" y="583900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5 min</a:t>
              </a:r>
              <a:endParaRPr lang="zh-CN" altLang="en-US" dirty="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8167B26B-4D7C-491B-84F5-A92BB29AB99B}"/>
                </a:ext>
              </a:extLst>
            </p:cNvPr>
            <p:cNvSpPr txBox="1"/>
            <p:nvPr/>
          </p:nvSpPr>
          <p:spPr>
            <a:xfrm rot="18046475">
              <a:off x="8844386" y="595196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 min</a:t>
              </a:r>
              <a:endParaRPr lang="zh-CN" altLang="en-US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29CB4D6C-40B4-4794-BF15-5CE4505A1F1D}"/>
                </a:ext>
              </a:extLst>
            </p:cNvPr>
            <p:cNvSpPr txBox="1"/>
            <p:nvPr/>
          </p:nvSpPr>
          <p:spPr>
            <a:xfrm rot="12371929">
              <a:off x="9991162" y="25837"/>
              <a:ext cx="430887" cy="121645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/>
                <a:t>RhoA-G14V</a:t>
              </a:r>
              <a:endParaRPr lang="zh-CN" altLang="en-US" sz="1600" dirty="0"/>
            </a:p>
          </p:txBody>
        </p:sp>
      </p:grpSp>
      <p:sp>
        <p:nvSpPr>
          <p:cNvPr id="44" name="矩形 43">
            <a:extLst>
              <a:ext uri="{FF2B5EF4-FFF2-40B4-BE49-F238E27FC236}">
                <a16:creationId xmlns:a16="http://schemas.microsoft.com/office/drawing/2014/main" id="{971EC89D-8614-4BAE-B685-BDD27B6E6D95}"/>
              </a:ext>
            </a:extLst>
          </p:cNvPr>
          <p:cNvSpPr/>
          <p:nvPr/>
        </p:nvSpPr>
        <p:spPr>
          <a:xfrm>
            <a:off x="2348157" y="2331447"/>
            <a:ext cx="1851807" cy="6717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7B1A4DFB-E638-497F-9C94-B6058621D6F4}"/>
              </a:ext>
            </a:extLst>
          </p:cNvPr>
          <p:cNvCxnSpPr>
            <a:cxnSpLocks/>
          </p:cNvCxnSpPr>
          <p:nvPr/>
        </p:nvCxnSpPr>
        <p:spPr>
          <a:xfrm>
            <a:off x="4176216" y="2812082"/>
            <a:ext cx="4743666" cy="24918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341F8000-24B4-4123-B2C4-F7DD4F997583}"/>
              </a:ext>
            </a:extLst>
          </p:cNvPr>
          <p:cNvSpPr txBox="1"/>
          <p:nvPr/>
        </p:nvSpPr>
        <p:spPr>
          <a:xfrm rot="12371929">
            <a:off x="1783430" y="339270"/>
            <a:ext cx="430887" cy="121645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/>
              <a:t>RhoA-T19N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5289900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">
            <a:extLst>
              <a:ext uri="{FF2B5EF4-FFF2-40B4-BE49-F238E27FC236}">
                <a16:creationId xmlns:a16="http://schemas.microsoft.com/office/drawing/2014/main" id="{0955897E-4309-4F9E-9BB3-6F7C9BC2A37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413" y="400048"/>
            <a:ext cx="3657600" cy="4510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4ECD659-37CA-4EE7-B163-1EBC6DD9D32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091" t="14677" r="1222" b="76055"/>
          <a:stretch/>
        </p:blipFill>
        <p:spPr>
          <a:xfrm>
            <a:off x="5631134" y="1410185"/>
            <a:ext cx="4257675" cy="475375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24601733-ABE7-45FB-9278-71CCC2A79E72}"/>
              </a:ext>
            </a:extLst>
          </p:cNvPr>
          <p:cNvSpPr txBox="1"/>
          <p:nvPr/>
        </p:nvSpPr>
        <p:spPr>
          <a:xfrm>
            <a:off x="10422209" y="1463206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C42</a:t>
            </a:r>
            <a:endParaRPr lang="zh-CN" altLang="en-US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5316102E-7D08-4C66-873A-538EF550990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72" b="52647"/>
          <a:stretch/>
        </p:blipFill>
        <p:spPr>
          <a:xfrm>
            <a:off x="8691563" y="2145791"/>
            <a:ext cx="3500437" cy="4666671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267DBE21-A8DB-4360-82D9-ABB193D7084E}"/>
              </a:ext>
            </a:extLst>
          </p:cNvPr>
          <p:cNvSpPr txBox="1"/>
          <p:nvPr/>
        </p:nvSpPr>
        <p:spPr>
          <a:xfrm>
            <a:off x="3892806" y="1047750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C42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77172FF-3EEF-44C0-9342-55EEFD8D96A4}"/>
              </a:ext>
            </a:extLst>
          </p:cNvPr>
          <p:cNvSpPr txBox="1"/>
          <p:nvPr/>
        </p:nvSpPr>
        <p:spPr>
          <a:xfrm>
            <a:off x="3892805" y="1545744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44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25634F4-8CE8-4059-93EC-AB6FB0218E57}"/>
              </a:ext>
            </a:extLst>
          </p:cNvPr>
          <p:cNvSpPr txBox="1"/>
          <p:nvPr/>
        </p:nvSpPr>
        <p:spPr>
          <a:xfrm>
            <a:off x="3767611" y="3536469"/>
            <a:ext cx="561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RK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C5FEB78-AB30-43D4-B7B9-BE2CB0815403}"/>
              </a:ext>
            </a:extLst>
          </p:cNvPr>
          <p:cNvSpPr txBox="1"/>
          <p:nvPr/>
        </p:nvSpPr>
        <p:spPr>
          <a:xfrm>
            <a:off x="3892805" y="622414"/>
            <a:ext cx="80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ERK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7B1A4DFB-E638-497F-9C94-B6058621D6F4}"/>
              </a:ext>
            </a:extLst>
          </p:cNvPr>
          <p:cNvCxnSpPr>
            <a:cxnSpLocks/>
          </p:cNvCxnSpPr>
          <p:nvPr/>
        </p:nvCxnSpPr>
        <p:spPr>
          <a:xfrm>
            <a:off x="8272593" y="1915076"/>
            <a:ext cx="1947732" cy="210923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A512A56F-4BAB-4372-A8C6-B5468B7EEB0D}"/>
              </a:ext>
            </a:extLst>
          </p:cNvPr>
          <p:cNvCxnSpPr>
            <a:cxnSpLocks/>
            <a:endCxn id="7" idx="1"/>
          </p:cNvCxnSpPr>
          <p:nvPr/>
        </p:nvCxnSpPr>
        <p:spPr>
          <a:xfrm>
            <a:off x="3767611" y="1233488"/>
            <a:ext cx="1863523" cy="414385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7009046F-583F-4713-A01A-C39F4FBE3448}"/>
              </a:ext>
            </a:extLst>
          </p:cNvPr>
          <p:cNvSpPr txBox="1"/>
          <p:nvPr/>
        </p:nvSpPr>
        <p:spPr>
          <a:xfrm>
            <a:off x="219033" y="167176"/>
            <a:ext cx="3015569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6A-CDC42-panel 1#</a:t>
            </a:r>
            <a:endParaRPr lang="zh-CN" altLang="en-US" dirty="0"/>
          </a:p>
        </p:txBody>
      </p: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5A43C123-00CF-463B-8E2C-9F241A4F7A25}"/>
              </a:ext>
            </a:extLst>
          </p:cNvPr>
          <p:cNvGrpSpPr/>
          <p:nvPr/>
        </p:nvGrpSpPr>
        <p:grpSpPr>
          <a:xfrm>
            <a:off x="7424638" y="479805"/>
            <a:ext cx="2237861" cy="1056420"/>
            <a:chOff x="7416534" y="120888"/>
            <a:chExt cx="2237861" cy="1056420"/>
          </a:xfrm>
        </p:grpSpPr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A3818673-2114-40FA-8A66-E144963C0CB5}"/>
                </a:ext>
              </a:extLst>
            </p:cNvPr>
            <p:cNvSpPr txBox="1"/>
            <p:nvPr/>
          </p:nvSpPr>
          <p:spPr>
            <a:xfrm rot="18046475">
              <a:off x="7092235" y="461058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0 min</a:t>
              </a:r>
              <a:endParaRPr lang="zh-CN" altLang="en-US" dirty="0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5EADB210-9D72-42A3-97D8-3D920E97D652}"/>
                </a:ext>
              </a:extLst>
            </p:cNvPr>
            <p:cNvSpPr txBox="1"/>
            <p:nvPr/>
          </p:nvSpPr>
          <p:spPr>
            <a:xfrm rot="18046475">
              <a:off x="7428968" y="483678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 min</a:t>
              </a:r>
              <a:endParaRPr lang="zh-CN" altLang="en-US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19006EAF-896C-463C-9DBC-4E52059A9CBB}"/>
                </a:ext>
              </a:extLst>
            </p:cNvPr>
            <p:cNvSpPr txBox="1"/>
            <p:nvPr/>
          </p:nvSpPr>
          <p:spPr>
            <a:xfrm rot="18046475">
              <a:off x="7834070" y="472368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5 min</a:t>
              </a:r>
              <a:endParaRPr lang="zh-CN" altLang="en-US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9255D6B3-1489-413C-85EC-3B3A77280D99}"/>
                </a:ext>
              </a:extLst>
            </p:cNvPr>
            <p:cNvSpPr txBox="1"/>
            <p:nvPr/>
          </p:nvSpPr>
          <p:spPr>
            <a:xfrm rot="18046475">
              <a:off x="8171011" y="461057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0 min</a:t>
              </a:r>
              <a:endParaRPr lang="zh-CN" altLang="en-US" dirty="0"/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0FF702DD-34AF-4467-8E5B-29214F8EBA64}"/>
                </a:ext>
              </a:extLst>
            </p:cNvPr>
            <p:cNvSpPr txBox="1"/>
            <p:nvPr/>
          </p:nvSpPr>
          <p:spPr>
            <a:xfrm rot="18046475">
              <a:off x="8546866" y="470145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5 min</a:t>
              </a:r>
              <a:endParaRPr lang="zh-CN" altLang="en-US" dirty="0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841C9C81-0D69-4E3E-8EF1-C7BC833B3B1F}"/>
                </a:ext>
              </a:extLst>
            </p:cNvPr>
            <p:cNvSpPr txBox="1"/>
            <p:nvPr/>
          </p:nvSpPr>
          <p:spPr>
            <a:xfrm rot="18046475">
              <a:off x="8960764" y="445187"/>
              <a:ext cx="1017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0 min</a:t>
              </a:r>
              <a:endParaRPr lang="zh-CN" altLang="en-US" dirty="0"/>
            </a:p>
          </p:txBody>
        </p:sp>
      </p:grpSp>
      <p:sp>
        <p:nvSpPr>
          <p:cNvPr id="52" name="文本框 51">
            <a:extLst>
              <a:ext uri="{FF2B5EF4-FFF2-40B4-BE49-F238E27FC236}">
                <a16:creationId xmlns:a16="http://schemas.microsoft.com/office/drawing/2014/main" id="{AAD24AAD-FD1B-4714-A351-7CF5F205A86F}"/>
              </a:ext>
            </a:extLst>
          </p:cNvPr>
          <p:cNvSpPr txBox="1"/>
          <p:nvPr/>
        </p:nvSpPr>
        <p:spPr>
          <a:xfrm rot="12005199">
            <a:off x="6264649" y="403851"/>
            <a:ext cx="400110" cy="113749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CDC42-G12V</a:t>
            </a:r>
            <a:endParaRPr lang="zh-CN" altLang="en-US" sz="120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C0F8649B-87DD-4DEF-B536-C68F7037913E}"/>
              </a:ext>
            </a:extLst>
          </p:cNvPr>
          <p:cNvSpPr txBox="1"/>
          <p:nvPr/>
        </p:nvSpPr>
        <p:spPr>
          <a:xfrm rot="12005199">
            <a:off x="6957435" y="456101"/>
            <a:ext cx="400110" cy="110382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CDC42-F37A</a:t>
            </a:r>
            <a:endParaRPr lang="zh-CN" altLang="en-US" sz="120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C651BBE2-02DE-4A11-9DCC-08FC84E4E0C2}"/>
              </a:ext>
            </a:extLst>
          </p:cNvPr>
          <p:cNvSpPr txBox="1"/>
          <p:nvPr/>
        </p:nvSpPr>
        <p:spPr>
          <a:xfrm rot="12005199">
            <a:off x="6647026" y="361212"/>
            <a:ext cx="400110" cy="112947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CDC42-T17N</a:t>
            </a:r>
            <a:endParaRPr lang="zh-CN" altLang="en-US" sz="1200" dirty="0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6C3B91FE-C5E3-4B5C-B01F-099F54600534}"/>
              </a:ext>
            </a:extLst>
          </p:cNvPr>
          <p:cNvSpPr/>
          <p:nvPr/>
        </p:nvSpPr>
        <p:spPr>
          <a:xfrm>
            <a:off x="7222592" y="1373227"/>
            <a:ext cx="2235733" cy="6189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03154075-F317-48F0-98F9-AAD4628DAD9E}"/>
              </a:ext>
            </a:extLst>
          </p:cNvPr>
          <p:cNvSpPr/>
          <p:nvPr/>
        </p:nvSpPr>
        <p:spPr>
          <a:xfrm>
            <a:off x="357022" y="985667"/>
            <a:ext cx="3562476" cy="431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94674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5316102E-7D08-4C66-873A-538EF550990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72" b="52647"/>
          <a:stretch/>
        </p:blipFill>
        <p:spPr>
          <a:xfrm>
            <a:off x="8620125" y="2854616"/>
            <a:ext cx="3500437" cy="4003384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7009046F-583F-4713-A01A-C39F4FBE3448}"/>
              </a:ext>
            </a:extLst>
          </p:cNvPr>
          <p:cNvSpPr txBox="1"/>
          <p:nvPr/>
        </p:nvSpPr>
        <p:spPr>
          <a:xfrm>
            <a:off x="219033" y="167176"/>
            <a:ext cx="3015569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6A-CDC42-panel 2#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1440E1A9-6357-4F93-883B-FC8CC6ADD4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629980"/>
            <a:ext cx="3383057" cy="404679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5B960E5-43B7-49C9-8545-A264DCED7682}"/>
              </a:ext>
            </a:extLst>
          </p:cNvPr>
          <p:cNvSpPr txBox="1"/>
          <p:nvPr/>
        </p:nvSpPr>
        <p:spPr>
          <a:xfrm>
            <a:off x="1746696" y="4511505"/>
            <a:ext cx="1037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2112.tif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E2656D9-5535-4386-BBB4-E2941698D207}"/>
              </a:ext>
            </a:extLst>
          </p:cNvPr>
          <p:cNvSpPr txBox="1"/>
          <p:nvPr/>
        </p:nvSpPr>
        <p:spPr>
          <a:xfrm>
            <a:off x="3236433" y="734756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44(1)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245DBFD-9BFF-4956-AA1E-4169D2BC8776}"/>
              </a:ext>
            </a:extLst>
          </p:cNvPr>
          <p:cNvSpPr txBox="1"/>
          <p:nvPr/>
        </p:nvSpPr>
        <p:spPr>
          <a:xfrm>
            <a:off x="3214924" y="1663133"/>
            <a:ext cx="11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Tubline</a:t>
            </a:r>
            <a:r>
              <a:rPr lang="en-US" altLang="zh-CN" dirty="0"/>
              <a:t>(1)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91C7EE6-04FB-40AF-B9F7-19DBEC7B98D0}"/>
              </a:ext>
            </a:extLst>
          </p:cNvPr>
          <p:cNvSpPr txBox="1"/>
          <p:nvPr/>
        </p:nvSpPr>
        <p:spPr>
          <a:xfrm>
            <a:off x="3214924" y="2403355"/>
            <a:ext cx="112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C42(1)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38C7DDE-03C4-49D2-9630-D532A3445287}"/>
              </a:ext>
            </a:extLst>
          </p:cNvPr>
          <p:cNvSpPr txBox="1"/>
          <p:nvPr/>
        </p:nvSpPr>
        <p:spPr>
          <a:xfrm>
            <a:off x="3199665" y="3403254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EGFR(1)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41FFFE0-1D76-4607-A31D-DA1B9D347D56}"/>
              </a:ext>
            </a:extLst>
          </p:cNvPr>
          <p:cNvSpPr txBox="1"/>
          <p:nvPr/>
        </p:nvSpPr>
        <p:spPr>
          <a:xfrm>
            <a:off x="3199665" y="1311025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44(2)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2A7E093-AD56-485F-AB41-20011DC2705E}"/>
              </a:ext>
            </a:extLst>
          </p:cNvPr>
          <p:cNvSpPr txBox="1"/>
          <p:nvPr/>
        </p:nvSpPr>
        <p:spPr>
          <a:xfrm>
            <a:off x="3199665" y="2018112"/>
            <a:ext cx="11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Tubline</a:t>
            </a:r>
            <a:r>
              <a:rPr lang="en-US" altLang="zh-CN" dirty="0"/>
              <a:t>(2)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92BDEC7-61FE-47C3-91F9-90A51F1CBF68}"/>
              </a:ext>
            </a:extLst>
          </p:cNvPr>
          <p:cNvSpPr txBox="1"/>
          <p:nvPr/>
        </p:nvSpPr>
        <p:spPr>
          <a:xfrm>
            <a:off x="3199665" y="2877187"/>
            <a:ext cx="112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C42(2)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F13A71D-0747-4FF7-827F-DB53380BA7EE}"/>
              </a:ext>
            </a:extLst>
          </p:cNvPr>
          <p:cNvSpPr txBox="1"/>
          <p:nvPr/>
        </p:nvSpPr>
        <p:spPr>
          <a:xfrm>
            <a:off x="3199665" y="3979523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EGFR(2)</a:t>
            </a:r>
            <a:endParaRPr lang="zh-CN" altLang="en-US" dirty="0"/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E6365D07-234F-479C-AE2A-7003E32C3E4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340" b="44988"/>
          <a:stretch/>
        </p:blipFill>
        <p:spPr>
          <a:xfrm>
            <a:off x="4933840" y="1363749"/>
            <a:ext cx="6202909" cy="1098464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D6D2B93C-8A5A-436F-B9AC-92D584DE779E}"/>
              </a:ext>
            </a:extLst>
          </p:cNvPr>
          <p:cNvSpPr txBox="1"/>
          <p:nvPr/>
        </p:nvSpPr>
        <p:spPr>
          <a:xfrm rot="18046475">
            <a:off x="6006115" y="770103"/>
            <a:ext cx="101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0 min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8F0C455-23BA-4F4F-A57D-D12DB616D1F2}"/>
              </a:ext>
            </a:extLst>
          </p:cNvPr>
          <p:cNvSpPr txBox="1"/>
          <p:nvPr/>
        </p:nvSpPr>
        <p:spPr>
          <a:xfrm rot="18046475">
            <a:off x="6581585" y="770104"/>
            <a:ext cx="101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 min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62431723-10FD-4C9C-9BD4-1A5DE7776C87}"/>
              </a:ext>
            </a:extLst>
          </p:cNvPr>
          <p:cNvSpPr txBox="1"/>
          <p:nvPr/>
        </p:nvSpPr>
        <p:spPr>
          <a:xfrm rot="18046475">
            <a:off x="7202328" y="770103"/>
            <a:ext cx="101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 min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785E0ED-2353-4E44-8E8C-36EE9B478D02}"/>
              </a:ext>
            </a:extLst>
          </p:cNvPr>
          <p:cNvSpPr txBox="1"/>
          <p:nvPr/>
        </p:nvSpPr>
        <p:spPr>
          <a:xfrm rot="18046475">
            <a:off x="7743744" y="708700"/>
            <a:ext cx="101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 min</a:t>
            </a:r>
            <a:endParaRPr lang="zh-CN" altLang="en-US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F8DBE09E-5270-4671-8312-03414D3AF323}"/>
              </a:ext>
            </a:extLst>
          </p:cNvPr>
          <p:cNvSpPr txBox="1"/>
          <p:nvPr/>
        </p:nvSpPr>
        <p:spPr>
          <a:xfrm rot="18046475">
            <a:off x="8255874" y="708701"/>
            <a:ext cx="101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 min</a:t>
            </a:r>
            <a:endParaRPr lang="zh-CN" altLang="en-US" dirty="0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4226F438-8348-4CCE-A2D5-3EF0BB2EAE63}"/>
              </a:ext>
            </a:extLst>
          </p:cNvPr>
          <p:cNvSpPr txBox="1"/>
          <p:nvPr/>
        </p:nvSpPr>
        <p:spPr>
          <a:xfrm rot="18046475">
            <a:off x="8747779" y="789807"/>
            <a:ext cx="101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0 min</a:t>
            </a:r>
            <a:endParaRPr lang="zh-CN" altLang="en-US" dirty="0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F6195A56-66D4-487A-A2C7-A7728D12EEE5}"/>
              </a:ext>
            </a:extLst>
          </p:cNvPr>
          <p:cNvSpPr txBox="1"/>
          <p:nvPr/>
        </p:nvSpPr>
        <p:spPr>
          <a:xfrm rot="18046475">
            <a:off x="9191561" y="507874"/>
            <a:ext cx="1628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C42-T17N</a:t>
            </a:r>
            <a:endParaRPr lang="zh-CN" altLang="en-US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EF8D01E0-7C7F-477E-A9AE-2921ED7D416C}"/>
              </a:ext>
            </a:extLst>
          </p:cNvPr>
          <p:cNvSpPr txBox="1"/>
          <p:nvPr/>
        </p:nvSpPr>
        <p:spPr>
          <a:xfrm rot="18046475">
            <a:off x="9836110" y="488170"/>
            <a:ext cx="1628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C42-G12V</a:t>
            </a:r>
            <a:endParaRPr lang="zh-CN" altLang="en-US" dirty="0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820717EF-332D-4DAB-B5B4-3ABBD249408E}"/>
              </a:ext>
            </a:extLst>
          </p:cNvPr>
          <p:cNvSpPr/>
          <p:nvPr/>
        </p:nvSpPr>
        <p:spPr>
          <a:xfrm>
            <a:off x="39728" y="2343924"/>
            <a:ext cx="3298785" cy="5332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7B1A4DFB-E638-497F-9C94-B6058621D6F4}"/>
              </a:ext>
            </a:extLst>
          </p:cNvPr>
          <p:cNvCxnSpPr>
            <a:cxnSpLocks/>
          </p:cNvCxnSpPr>
          <p:nvPr/>
        </p:nvCxnSpPr>
        <p:spPr>
          <a:xfrm flipV="1">
            <a:off x="3289669" y="1701376"/>
            <a:ext cx="2077661" cy="1102496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矩形 68">
            <a:extLst>
              <a:ext uri="{FF2B5EF4-FFF2-40B4-BE49-F238E27FC236}">
                <a16:creationId xmlns:a16="http://schemas.microsoft.com/office/drawing/2014/main" id="{58EF7B39-AD4A-4627-BA55-1D78F4F93EF2}"/>
              </a:ext>
            </a:extLst>
          </p:cNvPr>
          <p:cNvSpPr/>
          <p:nvPr/>
        </p:nvSpPr>
        <p:spPr>
          <a:xfrm>
            <a:off x="6126030" y="1373227"/>
            <a:ext cx="3332296" cy="6771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2" name="直接箭头连接符 71">
            <a:extLst>
              <a:ext uri="{FF2B5EF4-FFF2-40B4-BE49-F238E27FC236}">
                <a16:creationId xmlns:a16="http://schemas.microsoft.com/office/drawing/2014/main" id="{A9C821FC-49EC-466B-BBAD-F45E1A299C1F}"/>
              </a:ext>
            </a:extLst>
          </p:cNvPr>
          <p:cNvCxnSpPr>
            <a:cxnSpLocks/>
          </p:cNvCxnSpPr>
          <p:nvPr/>
        </p:nvCxnSpPr>
        <p:spPr>
          <a:xfrm>
            <a:off x="7548563" y="2030714"/>
            <a:ext cx="2600317" cy="2825594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825866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5316102E-7D08-4C66-873A-538EF550990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72" b="52647"/>
          <a:stretch/>
        </p:blipFill>
        <p:spPr>
          <a:xfrm>
            <a:off x="7277100" y="2180175"/>
            <a:ext cx="3776663" cy="4666671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7009046F-583F-4713-A01A-C39F4FBE3448}"/>
              </a:ext>
            </a:extLst>
          </p:cNvPr>
          <p:cNvSpPr txBox="1"/>
          <p:nvPr/>
        </p:nvSpPr>
        <p:spPr>
          <a:xfrm>
            <a:off x="219033" y="167176"/>
            <a:ext cx="2738250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6A-RacI-panel 1#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1315514-88D5-42BB-BF3A-5E34F664A9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214" y="1615040"/>
            <a:ext cx="4684542" cy="260903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3681EDF-2ACF-42CC-969C-BEE2D1BB7521}"/>
              </a:ext>
            </a:extLst>
          </p:cNvPr>
          <p:cNvSpPr txBox="1"/>
          <p:nvPr/>
        </p:nvSpPr>
        <p:spPr>
          <a:xfrm>
            <a:off x="4838548" y="3790038"/>
            <a:ext cx="872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acI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75E4591-92F1-4654-934A-DFABEBB1325B}"/>
              </a:ext>
            </a:extLst>
          </p:cNvPr>
          <p:cNvSpPr txBox="1"/>
          <p:nvPr/>
        </p:nvSpPr>
        <p:spPr>
          <a:xfrm>
            <a:off x="4829850" y="3356007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44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C947CBF-0F38-4DC2-9379-53429B188E34}"/>
              </a:ext>
            </a:extLst>
          </p:cNvPr>
          <p:cNvSpPr txBox="1"/>
          <p:nvPr/>
        </p:nvSpPr>
        <p:spPr>
          <a:xfrm>
            <a:off x="4855756" y="2954326"/>
            <a:ext cx="561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RK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6F771A1-BA20-445C-837F-6A8BC1006E7B}"/>
              </a:ext>
            </a:extLst>
          </p:cNvPr>
          <p:cNvSpPr txBox="1"/>
          <p:nvPr/>
        </p:nvSpPr>
        <p:spPr>
          <a:xfrm>
            <a:off x="4888019" y="2312298"/>
            <a:ext cx="514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kt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444A907-884E-49F5-867F-EB253903157C}"/>
              </a:ext>
            </a:extLst>
          </p:cNvPr>
          <p:cNvSpPr txBox="1"/>
          <p:nvPr/>
        </p:nvSpPr>
        <p:spPr>
          <a:xfrm>
            <a:off x="4867520" y="2671127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GFR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EB3F6DB-A9E0-40E4-A604-E417309FEEB5}"/>
              </a:ext>
            </a:extLst>
          </p:cNvPr>
          <p:cNvSpPr txBox="1"/>
          <p:nvPr/>
        </p:nvSpPr>
        <p:spPr>
          <a:xfrm rot="12005199">
            <a:off x="628284" y="833018"/>
            <a:ext cx="400110" cy="92429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G12V</a:t>
            </a:r>
            <a:endParaRPr lang="zh-CN" altLang="en-US" sz="12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450197B-29A0-4907-B76E-B42089CB495B}"/>
              </a:ext>
            </a:extLst>
          </p:cNvPr>
          <p:cNvSpPr txBox="1"/>
          <p:nvPr/>
        </p:nvSpPr>
        <p:spPr>
          <a:xfrm rot="12005199">
            <a:off x="939793" y="976921"/>
            <a:ext cx="400110" cy="75918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WT</a:t>
            </a:r>
            <a:endParaRPr lang="zh-CN" altLang="en-US" sz="12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0A41E18-253B-4976-ACEB-82A44C2AE700}"/>
              </a:ext>
            </a:extLst>
          </p:cNvPr>
          <p:cNvSpPr txBox="1"/>
          <p:nvPr/>
        </p:nvSpPr>
        <p:spPr>
          <a:xfrm rot="12005199">
            <a:off x="1274522" y="847248"/>
            <a:ext cx="400110" cy="89062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F37A</a:t>
            </a:r>
            <a:endParaRPr lang="zh-CN" altLang="en-US" sz="12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1A27A44-9752-4086-AB23-C35107580E51}"/>
              </a:ext>
            </a:extLst>
          </p:cNvPr>
          <p:cNvSpPr txBox="1"/>
          <p:nvPr/>
        </p:nvSpPr>
        <p:spPr>
          <a:xfrm rot="12005199">
            <a:off x="1591574" y="843886"/>
            <a:ext cx="400110" cy="91627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T17N</a:t>
            </a:r>
            <a:endParaRPr lang="zh-CN" altLang="en-US" sz="12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8A1727F-9948-4329-A50C-1B5D5D7DE974}"/>
              </a:ext>
            </a:extLst>
          </p:cNvPr>
          <p:cNvSpPr txBox="1"/>
          <p:nvPr/>
        </p:nvSpPr>
        <p:spPr>
          <a:xfrm rot="12005199">
            <a:off x="1888393" y="899750"/>
            <a:ext cx="400110" cy="85856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hoA-WT</a:t>
            </a:r>
            <a:endParaRPr lang="zh-CN" altLang="en-US" sz="12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80C4302-EDA5-4F20-8834-6225A92AB863}"/>
              </a:ext>
            </a:extLst>
          </p:cNvPr>
          <p:cNvSpPr txBox="1"/>
          <p:nvPr/>
        </p:nvSpPr>
        <p:spPr>
          <a:xfrm rot="12005199">
            <a:off x="2197250" y="790239"/>
            <a:ext cx="400110" cy="97238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CDC42-WT</a:t>
            </a:r>
            <a:endParaRPr lang="zh-CN" altLang="en-US" sz="1200" dirty="0"/>
          </a:p>
        </p:txBody>
      </p: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002CA4FF-9E8E-484F-A65A-8D54A074728C}"/>
              </a:ext>
            </a:extLst>
          </p:cNvPr>
          <p:cNvGrpSpPr/>
          <p:nvPr/>
        </p:nvGrpSpPr>
        <p:grpSpPr>
          <a:xfrm>
            <a:off x="2647234" y="785046"/>
            <a:ext cx="1822669" cy="1087977"/>
            <a:chOff x="7431923" y="136759"/>
            <a:chExt cx="1822669" cy="1087977"/>
          </a:xfrm>
        </p:grpSpPr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F5662887-D518-4544-9C0C-F95C5DA7FDC5}"/>
                </a:ext>
              </a:extLst>
            </p:cNvPr>
            <p:cNvSpPr txBox="1"/>
            <p:nvPr/>
          </p:nvSpPr>
          <p:spPr>
            <a:xfrm rot="18046475">
              <a:off x="7092235" y="476447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0 min</a:t>
              </a:r>
              <a:endParaRPr lang="zh-CN" altLang="en-US" sz="16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FBD81227-B6E5-497B-BA1E-79C9C1BA03CC}"/>
                </a:ext>
              </a:extLst>
            </p:cNvPr>
            <p:cNvSpPr txBox="1"/>
            <p:nvPr/>
          </p:nvSpPr>
          <p:spPr>
            <a:xfrm rot="18046475">
              <a:off x="7391391" y="511470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 min</a:t>
              </a:r>
              <a:endParaRPr lang="zh-CN" altLang="en-US" sz="1600" dirty="0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4331F033-D4EE-4D90-B4D2-692B011E2D27}"/>
                </a:ext>
              </a:extLst>
            </p:cNvPr>
            <p:cNvSpPr txBox="1"/>
            <p:nvPr/>
          </p:nvSpPr>
          <p:spPr>
            <a:xfrm rot="18046475">
              <a:off x="7659607" y="505649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5 min</a:t>
              </a:r>
              <a:endParaRPr lang="zh-CN" altLang="en-US" sz="1600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A82610DC-318B-45DE-AA25-5D28631214EB}"/>
                </a:ext>
              </a:extLst>
            </p:cNvPr>
            <p:cNvSpPr txBox="1"/>
            <p:nvPr/>
          </p:nvSpPr>
          <p:spPr>
            <a:xfrm rot="18046475">
              <a:off x="7945774" y="546494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10 min</a:t>
              </a:r>
              <a:endParaRPr lang="zh-CN" altLang="en-US" sz="1600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3A5611F8-51F5-42CC-BBFE-3AAAEFB1AC07}"/>
                </a:ext>
              </a:extLst>
            </p:cNvPr>
            <p:cNvSpPr txBox="1"/>
            <p:nvPr/>
          </p:nvSpPr>
          <p:spPr>
            <a:xfrm rot="18046475">
              <a:off x="8295664" y="546495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15 min</a:t>
              </a:r>
              <a:endParaRPr lang="zh-CN" altLang="en-US" sz="1600" dirty="0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FBB06EDE-3F94-4DA9-8FF8-D1FCE4027A72}"/>
                </a:ext>
              </a:extLst>
            </p:cNvPr>
            <p:cNvSpPr txBox="1"/>
            <p:nvPr/>
          </p:nvSpPr>
          <p:spPr>
            <a:xfrm rot="18046475">
              <a:off x="8576350" y="540836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0 min</a:t>
              </a:r>
              <a:endParaRPr lang="zh-CN" altLang="en-US" sz="1600" dirty="0"/>
            </a:p>
          </p:txBody>
        </p:sp>
      </p:grpSp>
      <p:sp>
        <p:nvSpPr>
          <p:cNvPr id="38" name="文本框 37">
            <a:extLst>
              <a:ext uri="{FF2B5EF4-FFF2-40B4-BE49-F238E27FC236}">
                <a16:creationId xmlns:a16="http://schemas.microsoft.com/office/drawing/2014/main" id="{F06AA24F-61CA-4643-8EDB-16BEC3BA1B36}"/>
              </a:ext>
            </a:extLst>
          </p:cNvPr>
          <p:cNvSpPr txBox="1"/>
          <p:nvPr/>
        </p:nvSpPr>
        <p:spPr>
          <a:xfrm rot="12233973">
            <a:off x="4430850" y="680001"/>
            <a:ext cx="400110" cy="115642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/>
              <a:t>RacI-G12V</a:t>
            </a:r>
            <a:endParaRPr lang="zh-CN" altLang="en-US" sz="14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6D8E1249-B394-4955-81C7-A937845878A8}"/>
              </a:ext>
            </a:extLst>
          </p:cNvPr>
          <p:cNvSpPr txBox="1"/>
          <p:nvPr/>
        </p:nvSpPr>
        <p:spPr>
          <a:xfrm rot="12005199">
            <a:off x="4641254" y="996496"/>
            <a:ext cx="430887" cy="85376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/>
              <a:t>RacI-WT</a:t>
            </a:r>
            <a:endParaRPr lang="zh-CN" altLang="en-US" sz="1200" dirty="0"/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C2019BE4-0A6F-4E29-90D1-7394B7A37DB2}"/>
              </a:ext>
            </a:extLst>
          </p:cNvPr>
          <p:cNvSpPr/>
          <p:nvPr/>
        </p:nvSpPr>
        <p:spPr>
          <a:xfrm>
            <a:off x="2404169" y="3750727"/>
            <a:ext cx="1684961" cy="5498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7B1A4DFB-E638-497F-9C94-B6058621D6F4}"/>
              </a:ext>
            </a:extLst>
          </p:cNvPr>
          <p:cNvCxnSpPr>
            <a:cxnSpLocks/>
          </p:cNvCxnSpPr>
          <p:nvPr/>
        </p:nvCxnSpPr>
        <p:spPr>
          <a:xfrm>
            <a:off x="4089130" y="4224069"/>
            <a:ext cx="4716733" cy="1290906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462321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5316102E-7D08-4C66-873A-538EF550990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72" b="52647"/>
          <a:stretch/>
        </p:blipFill>
        <p:spPr>
          <a:xfrm>
            <a:off x="7751503" y="2145872"/>
            <a:ext cx="3500437" cy="4666671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7009046F-583F-4713-A01A-C39F4FBE3448}"/>
              </a:ext>
            </a:extLst>
          </p:cNvPr>
          <p:cNvSpPr txBox="1"/>
          <p:nvPr/>
        </p:nvSpPr>
        <p:spPr>
          <a:xfrm>
            <a:off x="219033" y="167176"/>
            <a:ext cx="2738250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6A-RacI-panel 2#</a:t>
            </a:r>
            <a:endParaRPr lang="zh-CN" altLang="en-US" dirty="0"/>
          </a:p>
        </p:txBody>
      </p: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651C43A9-72F6-4C2C-9339-8F5D12629396}"/>
              </a:ext>
            </a:extLst>
          </p:cNvPr>
          <p:cNvGrpSpPr/>
          <p:nvPr/>
        </p:nvGrpSpPr>
        <p:grpSpPr>
          <a:xfrm>
            <a:off x="807513" y="1915076"/>
            <a:ext cx="4493150" cy="2519452"/>
            <a:chOff x="8685563" y="2723994"/>
            <a:chExt cx="2878794" cy="1804617"/>
          </a:xfrm>
        </p:grpSpPr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ABF888A7-EDA9-4CED-8387-47157C529F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85563" y="2723994"/>
              <a:ext cx="2878794" cy="1804617"/>
            </a:xfrm>
            <a:prstGeom prst="rect">
              <a:avLst/>
            </a:prstGeom>
          </p:spPr>
        </p:pic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DE9C173D-1862-4AA5-979D-41753B8EAEAE}"/>
                </a:ext>
              </a:extLst>
            </p:cNvPr>
            <p:cNvSpPr/>
            <p:nvPr/>
          </p:nvSpPr>
          <p:spPr>
            <a:xfrm>
              <a:off x="9104632" y="3427588"/>
              <a:ext cx="1186963" cy="28280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34" name="文本框 33">
            <a:extLst>
              <a:ext uri="{FF2B5EF4-FFF2-40B4-BE49-F238E27FC236}">
                <a16:creationId xmlns:a16="http://schemas.microsoft.com/office/drawing/2014/main" id="{5D0E8E3F-415D-44B9-9FB4-0324523E2C8B}"/>
              </a:ext>
            </a:extLst>
          </p:cNvPr>
          <p:cNvSpPr txBox="1"/>
          <p:nvPr/>
        </p:nvSpPr>
        <p:spPr>
          <a:xfrm>
            <a:off x="1441240" y="4372156"/>
            <a:ext cx="2704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 CDC </a:t>
            </a:r>
            <a:r>
              <a:rPr lang="en-US" altLang="zh-CN" dirty="0" err="1"/>
              <a:t>RacIsfdhh.tif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3600C6D-6A28-4615-AEC5-8DF26DFEAFF6}"/>
              </a:ext>
            </a:extLst>
          </p:cNvPr>
          <p:cNvSpPr txBox="1"/>
          <p:nvPr/>
        </p:nvSpPr>
        <p:spPr>
          <a:xfrm>
            <a:off x="5353050" y="2994156"/>
            <a:ext cx="12602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ve RacI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E260C97-2D14-48AF-9CDD-6C62796A3F1B}"/>
              </a:ext>
            </a:extLst>
          </p:cNvPr>
          <p:cNvSpPr txBox="1"/>
          <p:nvPr/>
        </p:nvSpPr>
        <p:spPr>
          <a:xfrm rot="12005199">
            <a:off x="4435341" y="1236742"/>
            <a:ext cx="400110" cy="92429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G12V</a:t>
            </a:r>
            <a:endParaRPr lang="zh-CN" altLang="en-US" sz="12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F086D96-ABA6-4414-8BF3-F3953FDED579}"/>
              </a:ext>
            </a:extLst>
          </p:cNvPr>
          <p:cNvSpPr txBox="1"/>
          <p:nvPr/>
        </p:nvSpPr>
        <p:spPr>
          <a:xfrm rot="12005199">
            <a:off x="4112908" y="1379948"/>
            <a:ext cx="400110" cy="75918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WT</a:t>
            </a:r>
            <a:endParaRPr lang="zh-CN" altLang="en-US" sz="12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2A37169-8014-4BC9-B824-9EE4EB034186}"/>
              </a:ext>
            </a:extLst>
          </p:cNvPr>
          <p:cNvSpPr txBox="1"/>
          <p:nvPr/>
        </p:nvSpPr>
        <p:spPr>
          <a:xfrm rot="12005199">
            <a:off x="4767236" y="1253573"/>
            <a:ext cx="400110" cy="89062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F37A</a:t>
            </a:r>
            <a:endParaRPr lang="zh-CN" altLang="en-US" sz="12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A7E13FD-7AB2-40E0-8ECE-6BF729DA4F70}"/>
              </a:ext>
            </a:extLst>
          </p:cNvPr>
          <p:cNvSpPr txBox="1"/>
          <p:nvPr/>
        </p:nvSpPr>
        <p:spPr>
          <a:xfrm rot="12005199">
            <a:off x="5104336" y="1289767"/>
            <a:ext cx="400110" cy="91627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T17N</a:t>
            </a:r>
            <a:endParaRPr lang="zh-CN" altLang="en-US" sz="12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C6C019C-8AAF-4C2E-867B-EFED1287896D}"/>
              </a:ext>
            </a:extLst>
          </p:cNvPr>
          <p:cNvSpPr txBox="1"/>
          <p:nvPr/>
        </p:nvSpPr>
        <p:spPr>
          <a:xfrm rot="12005199">
            <a:off x="3841062" y="1277188"/>
            <a:ext cx="400110" cy="85856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hoA-WT</a:t>
            </a:r>
            <a:endParaRPr lang="zh-CN" altLang="en-US" sz="12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1619170-6DBE-4771-A8E3-00A0F6629A8D}"/>
              </a:ext>
            </a:extLst>
          </p:cNvPr>
          <p:cNvSpPr txBox="1"/>
          <p:nvPr/>
        </p:nvSpPr>
        <p:spPr>
          <a:xfrm rot="12005199">
            <a:off x="3547316" y="1160436"/>
            <a:ext cx="400110" cy="97238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CDC42-WT</a:t>
            </a:r>
            <a:endParaRPr lang="zh-CN" altLang="en-US" sz="12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7979F55-C9FF-41CE-B29D-B8293E115833}"/>
              </a:ext>
            </a:extLst>
          </p:cNvPr>
          <p:cNvSpPr txBox="1"/>
          <p:nvPr/>
        </p:nvSpPr>
        <p:spPr>
          <a:xfrm rot="12005199">
            <a:off x="996015" y="1134911"/>
            <a:ext cx="400110" cy="92429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G12V</a:t>
            </a:r>
            <a:endParaRPr lang="zh-CN" altLang="en-US" sz="12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B705CBA-412C-4444-9949-0AD7D1F2699D}"/>
              </a:ext>
            </a:extLst>
          </p:cNvPr>
          <p:cNvSpPr txBox="1"/>
          <p:nvPr/>
        </p:nvSpPr>
        <p:spPr>
          <a:xfrm rot="12005199">
            <a:off x="1283301" y="1294546"/>
            <a:ext cx="400110" cy="75918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400" dirty="0"/>
              <a:t>RacI-WT</a:t>
            </a:r>
            <a:endParaRPr lang="zh-CN" altLang="en-US" sz="1200" dirty="0"/>
          </a:p>
        </p:txBody>
      </p: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292AA027-2E62-48E9-96F6-1F6F38607AE4}"/>
              </a:ext>
            </a:extLst>
          </p:cNvPr>
          <p:cNvGrpSpPr/>
          <p:nvPr/>
        </p:nvGrpSpPr>
        <p:grpSpPr>
          <a:xfrm>
            <a:off x="1723431" y="1048609"/>
            <a:ext cx="1822669" cy="1087977"/>
            <a:chOff x="7431923" y="136759"/>
            <a:chExt cx="1822669" cy="1087977"/>
          </a:xfrm>
        </p:grpSpPr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F815060A-232E-4897-B31B-B069628790A1}"/>
                </a:ext>
              </a:extLst>
            </p:cNvPr>
            <p:cNvSpPr txBox="1"/>
            <p:nvPr/>
          </p:nvSpPr>
          <p:spPr>
            <a:xfrm rot="18046475">
              <a:off x="7092235" y="476447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0 min</a:t>
              </a:r>
              <a:endParaRPr lang="zh-CN" altLang="en-US" sz="1600" dirty="0"/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2796ECA4-853E-4934-B83A-76084024B3E7}"/>
                </a:ext>
              </a:extLst>
            </p:cNvPr>
            <p:cNvSpPr txBox="1"/>
            <p:nvPr/>
          </p:nvSpPr>
          <p:spPr>
            <a:xfrm rot="18046475">
              <a:off x="7391391" y="511470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15 min</a:t>
              </a:r>
              <a:endParaRPr lang="zh-CN" altLang="en-US" sz="1600" dirty="0"/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655B0046-2C7A-496A-B54E-67F06F461F20}"/>
                </a:ext>
              </a:extLst>
            </p:cNvPr>
            <p:cNvSpPr txBox="1"/>
            <p:nvPr/>
          </p:nvSpPr>
          <p:spPr>
            <a:xfrm rot="18046475">
              <a:off x="7659607" y="505649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10 min</a:t>
              </a:r>
              <a:endParaRPr lang="zh-CN" altLang="en-US" sz="1600" dirty="0"/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DAC5161A-C4A0-4C3C-94C1-6105A8826201}"/>
                </a:ext>
              </a:extLst>
            </p:cNvPr>
            <p:cNvSpPr txBox="1"/>
            <p:nvPr/>
          </p:nvSpPr>
          <p:spPr>
            <a:xfrm rot="18046475">
              <a:off x="7945774" y="546494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5 min</a:t>
              </a:r>
              <a:endParaRPr lang="zh-CN" altLang="en-US" sz="1600" dirty="0"/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9FB21522-8101-4DF0-A426-52E19E87B427}"/>
                </a:ext>
              </a:extLst>
            </p:cNvPr>
            <p:cNvSpPr txBox="1"/>
            <p:nvPr/>
          </p:nvSpPr>
          <p:spPr>
            <a:xfrm rot="18046475">
              <a:off x="8295664" y="546495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 min</a:t>
              </a:r>
              <a:endParaRPr lang="zh-CN" altLang="en-US" sz="1600" dirty="0"/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5B9F5C58-727B-4472-BD58-F1111DBA43C8}"/>
                </a:ext>
              </a:extLst>
            </p:cNvPr>
            <p:cNvSpPr txBox="1"/>
            <p:nvPr/>
          </p:nvSpPr>
          <p:spPr>
            <a:xfrm rot="18046475">
              <a:off x="8576350" y="540836"/>
              <a:ext cx="1017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0 min</a:t>
              </a:r>
              <a:endParaRPr lang="zh-CN" altLang="en-US" sz="1600" dirty="0"/>
            </a:p>
          </p:txBody>
        </p:sp>
      </p:grp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7B1A4DFB-E638-497F-9C94-B6058621D6F4}"/>
              </a:ext>
            </a:extLst>
          </p:cNvPr>
          <p:cNvCxnSpPr>
            <a:cxnSpLocks/>
          </p:cNvCxnSpPr>
          <p:nvPr/>
        </p:nvCxnSpPr>
        <p:spPr>
          <a:xfrm>
            <a:off x="3054088" y="3292201"/>
            <a:ext cx="6904300" cy="2575199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70162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00428</TotalTime>
  <Words>178</Words>
  <Application>Microsoft Office PowerPoint</Application>
  <PresentationFormat>宽屏</PresentationFormat>
  <Paragraphs>97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g Weibing</dc:creator>
  <cp:lastModifiedBy>Leng Weibing</cp:lastModifiedBy>
  <cp:revision>10</cp:revision>
  <dcterms:created xsi:type="dcterms:W3CDTF">2020-10-11T15:01:22Z</dcterms:created>
  <dcterms:modified xsi:type="dcterms:W3CDTF">2020-10-13T05:39:59Z</dcterms:modified>
</cp:coreProperties>
</file>